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0" r:id="rId1"/>
  </p:sldMasterIdLst>
  <p:notesMasterIdLst>
    <p:notesMasterId r:id="rId5"/>
  </p:notesMasterIdLst>
  <p:sldIdLst>
    <p:sldId id="7131" r:id="rId2"/>
    <p:sldId id="7136" r:id="rId3"/>
    <p:sldId id="7133" r:id="rId4"/>
  </p:sldIdLst>
  <p:sldSz cx="32004000" cy="34747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28" userDrawn="1">
          <p15:clr>
            <a:srgbClr val="A4A3A4"/>
          </p15:clr>
        </p15:guide>
        <p15:guide id="2" pos="11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5400" autoAdjust="0"/>
  </p:normalViewPr>
  <p:slideViewPr>
    <p:cSldViewPr snapToGrid="0" showGuides="1">
      <p:cViewPr>
        <p:scale>
          <a:sx n="50" d="100"/>
          <a:sy n="50" d="100"/>
        </p:scale>
        <p:origin x="1422" y="-3108"/>
      </p:cViewPr>
      <p:guideLst>
        <p:guide orient="horz" pos="5928"/>
        <p:guide pos="11136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160E8B-8603-4386-B3D8-EDFBECC72356}" type="datetimeFigureOut">
              <a:rPr lang="ko-KR" altLang="en-US" smtClean="0"/>
              <a:t>2025-09-04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1143000"/>
            <a:ext cx="2841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A2F9E5-8A1A-40EF-89C4-CF4CD0B150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76486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1pPr>
    <a:lvl2pPr marL="529758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2pPr>
    <a:lvl3pPr marL="1059515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3pPr>
    <a:lvl4pPr marL="1589273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4pPr>
    <a:lvl5pPr marL="2119031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5pPr>
    <a:lvl6pPr marL="2648788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6pPr>
    <a:lvl7pPr marL="3178546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7pPr>
    <a:lvl8pPr marL="3708303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8pPr>
    <a:lvl9pPr marL="4238061" algn="l" defTabSz="1059515" rtl="0" eaLnBrk="1" latinLnBrk="1" hangingPunct="1">
      <a:defRPr sz="139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432559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10612" userDrawn="1">
          <p15:clr>
            <a:srgbClr val="FBAE40"/>
          </p15:clr>
        </p15:guide>
        <p15:guide id="2" pos="11291" userDrawn="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2200275" y="32205514"/>
            <a:ext cx="7200900" cy="1849967"/>
          </a:xfrm>
          <a:prstGeom prst="rect">
            <a:avLst/>
          </a:prstGeom>
        </p:spPr>
        <p:txBody>
          <a:bodyPr/>
          <a:lstStyle/>
          <a:p>
            <a:fld id="{57000D8A-85A0-4198-9D40-287B92A8E529}" type="datetimeFigureOut">
              <a:rPr lang="ko-KR" altLang="en-US" smtClean="0"/>
              <a:t>2025-09-0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10601325" y="32205514"/>
            <a:ext cx="10801350" cy="1849967"/>
          </a:xfrm>
          <a:prstGeom prst="rect">
            <a:avLst/>
          </a:prstGeom>
        </p:spPr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22602825" y="32205514"/>
            <a:ext cx="7200900" cy="1849967"/>
          </a:xfrm>
          <a:prstGeom prst="rect">
            <a:avLst/>
          </a:prstGeom>
        </p:spPr>
        <p:txBody>
          <a:bodyPr/>
          <a:lstStyle/>
          <a:p>
            <a:fld id="{827E9B40-925A-4565-9C97-14A0CEB9ADF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4775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 column 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7"/>
          <p:cNvSpPr txBox="1">
            <a:spLocks noGrp="1"/>
          </p:cNvSpPr>
          <p:nvPr>
            <p:ph type="title"/>
          </p:nvPr>
        </p:nvSpPr>
        <p:spPr>
          <a:xfrm>
            <a:off x="2496288" y="5643086"/>
            <a:ext cx="16500750" cy="7628373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300"/>
              <a:buNone/>
              <a:defRPr>
                <a:latin typeface="+mn-lt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33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body" idx="1"/>
          </p:nvPr>
        </p:nvSpPr>
        <p:spPr>
          <a:xfrm>
            <a:off x="16254612" y="16169254"/>
            <a:ext cx="13253100" cy="14048853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1600161" lvl="0" indent="-1111223">
              <a:spcBef>
                <a:spcPts val="0"/>
              </a:spcBef>
              <a:spcAft>
                <a:spcPts val="0"/>
              </a:spcAft>
              <a:buSzPts val="1400"/>
              <a:buChar char="●"/>
              <a:defRPr>
                <a:latin typeface="+mn-lt"/>
              </a:defRPr>
            </a:lvl1pPr>
            <a:lvl2pPr marL="3200321" lvl="1" indent="-11112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4800479" lvl="2" indent="-11112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6400640" lvl="3" indent="-11112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8000801" lvl="4" indent="-11112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9600961" lvl="5" indent="-11112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11201119" lvl="6" indent="-11112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12801280" lvl="7" indent="-11112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14401440" lvl="8" indent="-11112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sldNum" idx="12"/>
          </p:nvPr>
        </p:nvSpPr>
        <p:spPr>
          <a:xfrm>
            <a:off x="29127525" y="1222754"/>
            <a:ext cx="1920450" cy="1771307"/>
          </a:xfrm>
          <a:prstGeom prst="rect">
            <a:avLst/>
          </a:prstGeom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 rtl="0">
              <a:buNone/>
              <a:defRPr sz="4200">
                <a:solidFill>
                  <a:schemeClr val="accent1"/>
                </a:solidFill>
                <a:latin typeface="+mn-lt"/>
                <a:ea typeface="Manrope SemiBold"/>
                <a:cs typeface="Manrope SemiBold"/>
                <a:sym typeface="Manrope SemiBold"/>
              </a:defRPr>
            </a:lvl1pPr>
            <a:lvl2pPr lvl="1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2pPr>
            <a:lvl3pPr lvl="2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3pPr>
            <a:lvl4pPr lvl="3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4pPr>
            <a:lvl5pPr lvl="4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5pPr>
            <a:lvl6pPr lvl="5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6pPr>
            <a:lvl7pPr lvl="6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7pPr>
            <a:lvl8pPr lvl="7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8pPr>
            <a:lvl9pPr lvl="8" algn="r" rtl="0">
              <a:buNone/>
              <a:defRPr sz="4200">
                <a:solidFill>
                  <a:schemeClr val="accent1"/>
                </a:solidFill>
                <a:latin typeface="Manrope SemiBold"/>
                <a:ea typeface="Manrope SemiBold"/>
                <a:cs typeface="Manrope SemiBold"/>
                <a:sym typeface="Manrope SemiBold"/>
              </a:defRPr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  <p:sp>
        <p:nvSpPr>
          <p:cNvPr id="2" name="Google Shape;307;p37">
            <a:extLst>
              <a:ext uri="{FF2B5EF4-FFF2-40B4-BE49-F238E27FC236}">
                <a16:creationId xmlns:a16="http://schemas.microsoft.com/office/drawing/2014/main" id="{E73BAD69-AC13-9293-DF69-52FD72E8F3FB}"/>
              </a:ext>
            </a:extLst>
          </p:cNvPr>
          <p:cNvSpPr txBox="1">
            <a:spLocks/>
          </p:cNvSpPr>
          <p:nvPr/>
        </p:nvSpPr>
        <p:spPr>
          <a:xfrm>
            <a:off x="735643" y="1473024"/>
            <a:ext cx="16500750" cy="3108061"/>
          </a:xfrm>
          <a:prstGeom prst="rect">
            <a:avLst/>
          </a:prstGeom>
        </p:spPr>
        <p:txBody>
          <a:bodyPr spcFirstLastPara="1" wrap="square" lIns="319988" tIns="319988" rIns="319988" bIns="319988" anchor="b" anchorCtr="0">
            <a:no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2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 lang="de-DE" sz="7001" b="1" dirty="0">
              <a:latin typeface="+mn-lt"/>
              <a:ea typeface="Manrope"/>
              <a:cs typeface="Manrope"/>
              <a:sym typeface="Manrope"/>
            </a:endParaRPr>
          </a:p>
        </p:txBody>
      </p:sp>
      <p:cxnSp>
        <p:nvCxnSpPr>
          <p:cNvPr id="3" name="Google Shape;310;p37">
            <a:extLst>
              <a:ext uri="{FF2B5EF4-FFF2-40B4-BE49-F238E27FC236}">
                <a16:creationId xmlns:a16="http://schemas.microsoft.com/office/drawing/2014/main" id="{96EEF8EE-9461-850D-7994-849529E77F44}"/>
              </a:ext>
            </a:extLst>
          </p:cNvPr>
          <p:cNvCxnSpPr/>
          <p:nvPr/>
        </p:nvCxnSpPr>
        <p:spPr>
          <a:xfrm>
            <a:off x="916212" y="5103334"/>
            <a:ext cx="306768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4" name="Google Shape;307;p37">
            <a:extLst>
              <a:ext uri="{FF2B5EF4-FFF2-40B4-BE49-F238E27FC236}">
                <a16:creationId xmlns:a16="http://schemas.microsoft.com/office/drawing/2014/main" id="{F4F7A8CA-F5A7-9F1F-ED53-7CF5DF78075F}"/>
              </a:ext>
            </a:extLst>
          </p:cNvPr>
          <p:cNvSpPr txBox="1">
            <a:spLocks/>
          </p:cNvSpPr>
          <p:nvPr userDrawn="1"/>
        </p:nvSpPr>
        <p:spPr>
          <a:xfrm>
            <a:off x="735643" y="1473024"/>
            <a:ext cx="16500750" cy="3108061"/>
          </a:xfrm>
          <a:prstGeom prst="rect">
            <a:avLst/>
          </a:prstGeom>
        </p:spPr>
        <p:txBody>
          <a:bodyPr spcFirstLastPara="1" wrap="square" lIns="319988" tIns="319988" rIns="319988" bIns="319988" anchor="b" anchorCtr="0">
            <a:no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2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 lang="de-DE" sz="7001" b="1" dirty="0">
              <a:latin typeface="+mn-lt"/>
              <a:ea typeface="Manrope"/>
              <a:cs typeface="Manrope"/>
              <a:sym typeface="Manrope"/>
            </a:endParaRPr>
          </a:p>
        </p:txBody>
      </p:sp>
      <p:cxnSp>
        <p:nvCxnSpPr>
          <p:cNvPr id="5" name="Google Shape;310;p37">
            <a:extLst>
              <a:ext uri="{FF2B5EF4-FFF2-40B4-BE49-F238E27FC236}">
                <a16:creationId xmlns:a16="http://schemas.microsoft.com/office/drawing/2014/main" id="{B4181FEA-B946-5051-D019-2D5D06B59071}"/>
              </a:ext>
            </a:extLst>
          </p:cNvPr>
          <p:cNvCxnSpPr/>
          <p:nvPr userDrawn="1"/>
        </p:nvCxnSpPr>
        <p:spPr>
          <a:xfrm>
            <a:off x="916212" y="5103334"/>
            <a:ext cx="306768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</p:cxnSp>
    </p:spTree>
    <p:extLst>
      <p:ext uri="{BB962C8B-B14F-4D97-AF65-F5344CB8AC3E}">
        <p14:creationId xmlns:p14="http://schemas.microsoft.com/office/powerpoint/2010/main" val="391879021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1620">
          <p15:clr>
            <a:srgbClr val="FBAE40"/>
          </p15:clr>
        </p15:guide>
        <p15:guide id="2" pos="2880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62885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2" r:id="rId1"/>
    <p:sldLayoutId id="2147483687" r:id="rId2"/>
    <p:sldLayoutId id="2147483693" r:id="rId3"/>
  </p:sldLayoutIdLst>
  <p:txStyles>
    <p:titleStyle>
      <a:lvl1pPr algn="l" defTabSz="3200400" rtl="0" eaLnBrk="1" latinLnBrk="1" hangingPunct="1">
        <a:lnSpc>
          <a:spcPct val="90000"/>
        </a:lnSpc>
        <a:spcBef>
          <a:spcPct val="0"/>
        </a:spcBef>
        <a:buNone/>
        <a:defRPr sz="15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00100" indent="-800100" algn="l" defTabSz="3200400" rtl="0" eaLnBrk="1" latinLnBrk="1" hangingPunct="1">
        <a:lnSpc>
          <a:spcPct val="90000"/>
        </a:lnSpc>
        <a:spcBef>
          <a:spcPts val="3500"/>
        </a:spcBef>
        <a:buFont typeface="Arial" panose="020B0604020202020204" pitchFamily="34" charset="0"/>
        <a:buChar char="•"/>
        <a:defRPr sz="9800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2pPr>
      <a:lvl3pPr marL="40005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3pPr>
      <a:lvl4pPr marL="56007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4pPr>
      <a:lvl5pPr marL="72009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5pPr>
      <a:lvl6pPr marL="88011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6pPr>
      <a:lvl7pPr marL="104013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7pPr>
      <a:lvl8pPr marL="120015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8pPr>
      <a:lvl9pPr marL="13601700" indent="-800100" algn="l" defTabSz="3200400" rtl="0" eaLnBrk="1" latinLnBrk="1" hangingPunct="1">
        <a:lnSpc>
          <a:spcPct val="90000"/>
        </a:lnSpc>
        <a:spcBef>
          <a:spcPts val="17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1pPr>
      <a:lvl2pPr marL="16002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2pPr>
      <a:lvl3pPr marL="32004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4pPr>
      <a:lvl5pPr marL="64008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5pPr>
      <a:lvl6pPr marL="80010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6pPr>
      <a:lvl7pPr marL="96012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7pPr>
      <a:lvl8pPr marL="112014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8pPr>
      <a:lvl9pPr marL="12801600" algn="l" defTabSz="3200400" rtl="0" eaLnBrk="1" latinLnBrk="1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10944" userDrawn="1">
          <p15:clr>
            <a:srgbClr val="F26B43"/>
          </p15:clr>
        </p15:guide>
        <p15:guide id="2" pos="1008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B7FEB4A-532F-E732-49C7-E8AF827483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63588206-B773-5E4D-53E3-D3BEFDC154DD}"/>
              </a:ext>
            </a:extLst>
          </p:cNvPr>
          <p:cNvGrpSpPr/>
          <p:nvPr/>
        </p:nvGrpSpPr>
        <p:grpSpPr>
          <a:xfrm>
            <a:off x="1748137" y="3622390"/>
            <a:ext cx="28202924" cy="11443490"/>
            <a:chOff x="1748137" y="3622390"/>
            <a:chExt cx="28202924" cy="1144349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EF7012AC-78CC-D79D-C6C6-2D84D4271D1B}"/>
                </a:ext>
              </a:extLst>
            </p:cNvPr>
            <p:cNvGrpSpPr/>
            <p:nvPr/>
          </p:nvGrpSpPr>
          <p:grpSpPr>
            <a:xfrm>
              <a:off x="1748137" y="4323110"/>
              <a:ext cx="25903235" cy="9960819"/>
              <a:chOff x="314326" y="1873379"/>
              <a:chExt cx="9867899" cy="3794598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3D417B81-D747-27DB-E7EE-4DE6E0386A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5026" b="89947" l="9927" r="97810">
                            <a14:foregroundMark x1="68903" y1="7387" x2="86277" y2="5026"/>
                            <a14:foregroundMark x1="86277" y1="5026" x2="97574" y2="9172"/>
                            <a14:foregroundMark x1="97226" y1="5026" x2="94891" y2="8201"/>
                            <a14:foregroundMark x1="81752" y1="16138" x2="78978" y2="14021"/>
                            <a14:backgroundMark x1="68613" y1="7143" x2="69051" y2="6878"/>
                            <a14:backgroundMark x1="98248" y1="9259" x2="97518" y2="8995"/>
                          </a14:backgroundRemoval>
                        </a14:imgEffect>
                        <a14:imgEffect>
                          <a14:sharpenSoften amount="25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67810" b="80342"/>
              <a:stretch/>
            </p:blipFill>
            <p:spPr>
              <a:xfrm>
                <a:off x="314326" y="1873379"/>
                <a:ext cx="1190625" cy="401231"/>
              </a:xfrm>
              <a:prstGeom prst="rect">
                <a:avLst/>
              </a:prstGeom>
            </p:spPr>
          </p:pic>
          <p:cxnSp>
            <p:nvCxnSpPr>
              <p:cNvPr id="6" name="Straight Arrow Connector 5">
                <a:extLst>
                  <a:ext uri="{FF2B5EF4-FFF2-40B4-BE49-F238E27FC236}">
                    <a16:creationId xmlns:a16="http://schemas.microsoft.com/office/drawing/2014/main" id="{58CF6F5E-0F2A-1F0A-1DE3-23B9C83848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6275" y="2886075"/>
                <a:ext cx="9505950" cy="8355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2AD1162-B581-6831-C922-95A6D450B14F}"/>
                  </a:ext>
                </a:extLst>
              </p:cNvPr>
              <p:cNvSpPr txBox="1"/>
              <p:nvPr/>
            </p:nvSpPr>
            <p:spPr>
              <a:xfrm>
                <a:off x="314326" y="2452745"/>
                <a:ext cx="1190625" cy="26967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de-DE" altLang="ko-KR" sz="4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4 days</a:t>
                </a:r>
                <a:endParaRPr lang="ko-KR" alt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AD314F45-C847-56B4-8966-335B923A15A3}"/>
                  </a:ext>
                </a:extLst>
              </p:cNvPr>
              <p:cNvCxnSpPr/>
              <p:nvPr/>
            </p:nvCxnSpPr>
            <p:spPr>
              <a:xfrm>
                <a:off x="676275" y="2748794"/>
                <a:ext cx="0" cy="274562"/>
              </a:xfrm>
              <a:prstGeom prst="line">
                <a:avLst/>
              </a:prstGeom>
              <a:ln w="28575"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8087ED73-5C31-17D4-7522-2C126992681E}"/>
                  </a:ext>
                </a:extLst>
              </p:cNvPr>
              <p:cNvCxnSpPr/>
              <p:nvPr/>
            </p:nvCxnSpPr>
            <p:spPr>
              <a:xfrm>
                <a:off x="6410323" y="2767844"/>
                <a:ext cx="0" cy="274562"/>
              </a:xfrm>
              <a:prstGeom prst="line">
                <a:avLst/>
              </a:prstGeom>
              <a:ln w="28575"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82B91904-651A-7877-7362-AFDC80A3D8D4}"/>
                  </a:ext>
                </a:extLst>
              </p:cNvPr>
              <p:cNvCxnSpPr/>
              <p:nvPr/>
            </p:nvCxnSpPr>
            <p:spPr>
              <a:xfrm>
                <a:off x="9793944" y="2749101"/>
                <a:ext cx="0" cy="274562"/>
              </a:xfrm>
              <a:prstGeom prst="line">
                <a:avLst/>
              </a:prstGeom>
              <a:ln w="28575"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0EDD984-FE13-C5CC-62A8-DA1244EAA6A8}"/>
                  </a:ext>
                </a:extLst>
              </p:cNvPr>
              <p:cNvSpPr txBox="1"/>
              <p:nvPr/>
            </p:nvSpPr>
            <p:spPr>
              <a:xfrm>
                <a:off x="3211395" y="3098699"/>
                <a:ext cx="691171" cy="26967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txBody>
              <a:bodyPr wrap="square">
                <a:spAutoFit/>
              </a:bodyPr>
              <a:lstStyle/>
              <a:p>
                <a:r>
                  <a:rPr lang="de-DE" altLang="ko-KR" sz="4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0</a:t>
                </a:r>
                <a:endParaRPr lang="ko-KR" alt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20B2C32-91E9-5369-1712-C7D466284D31}"/>
                  </a:ext>
                </a:extLst>
              </p:cNvPr>
              <p:cNvSpPr txBox="1"/>
              <p:nvPr/>
            </p:nvSpPr>
            <p:spPr>
              <a:xfrm>
                <a:off x="6112669" y="3074274"/>
                <a:ext cx="1190625" cy="26967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de-DE" altLang="ko-KR" sz="4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4</a:t>
                </a:r>
                <a:endParaRPr lang="ko-KR" alt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A93B6E8-F995-E592-06A1-648179710678}"/>
                  </a:ext>
                </a:extLst>
              </p:cNvPr>
              <p:cNvSpPr txBox="1"/>
              <p:nvPr/>
            </p:nvSpPr>
            <p:spPr>
              <a:xfrm>
                <a:off x="2718285" y="5373586"/>
                <a:ext cx="2062707" cy="269671"/>
              </a:xfrm>
              <a:prstGeom prst="rect">
                <a:avLst/>
              </a:prstGeom>
              <a:solidFill>
                <a:schemeClr val="bg1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altLang="ko-KR" sz="4000" b="1" dirty="0">
                    <a:solidFill>
                      <a:schemeClr val="accent2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 measurement</a:t>
                </a:r>
                <a:endParaRPr lang="ko-KR" altLang="en-US" sz="4000" b="1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1A4925D5-F546-D062-337D-96E4DC1A65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35690" y="5483506"/>
                <a:ext cx="0" cy="184471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9ED6FDD6-EBA0-E011-F358-E7C0597EC3DE}"/>
                  </a:ext>
                </a:extLst>
              </p:cNvPr>
              <p:cNvCxnSpPr/>
              <p:nvPr/>
            </p:nvCxnSpPr>
            <p:spPr>
              <a:xfrm>
                <a:off x="3514726" y="2757149"/>
                <a:ext cx="0" cy="274562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11BB9D13-965D-7FA3-AFC7-D3788FE234C4}"/>
                  </a:ext>
                </a:extLst>
              </p:cNvPr>
              <p:cNvSpPr txBox="1"/>
              <p:nvPr/>
            </p:nvSpPr>
            <p:spPr>
              <a:xfrm>
                <a:off x="8603319" y="3017865"/>
                <a:ext cx="1190625" cy="26967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de-DE" altLang="ko-KR" sz="4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ay 19</a:t>
                </a:r>
                <a:endParaRPr lang="ko-KR" altLang="en-US" sz="4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557544F9-D1CA-55A6-F754-F45D2DD003F4}"/>
                  </a:ext>
                </a:extLst>
              </p:cNvPr>
              <p:cNvCxnSpPr/>
              <p:nvPr/>
            </p:nvCxnSpPr>
            <p:spPr>
              <a:xfrm>
                <a:off x="9096375" y="2729129"/>
                <a:ext cx="0" cy="274562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6ADD8119-8DA8-6F23-F25F-C58B0A1B727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56980" y="4914900"/>
                <a:ext cx="5539395" cy="0"/>
              </a:xfrm>
              <a:prstGeom prst="straightConnector1">
                <a:avLst/>
              </a:prstGeom>
              <a:ln w="762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A539F61-99E9-C0EF-1D73-15CAEB3D31BE}"/>
                  </a:ext>
                </a:extLst>
              </p:cNvPr>
              <p:cNvSpPr txBox="1"/>
              <p:nvPr/>
            </p:nvSpPr>
            <p:spPr>
              <a:xfrm>
                <a:off x="3514726" y="4943640"/>
                <a:ext cx="1649072" cy="2696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altLang="ko-KR" sz="40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mple feeding</a:t>
                </a:r>
                <a:endParaRPr lang="ko-KR" altLang="en-US" sz="40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03A38E10-8B36-2DB0-3CCB-B9E2D4847273}"/>
                  </a:ext>
                </a:extLst>
              </p:cNvPr>
              <p:cNvCxnSpPr>
                <a:cxnSpLocks/>
                <a:stCxn id="17" idx="2"/>
              </p:cNvCxnSpPr>
              <p:nvPr/>
            </p:nvCxnSpPr>
            <p:spPr>
              <a:xfrm flipH="1">
                <a:off x="3514726" y="3368370"/>
                <a:ext cx="0" cy="1727734"/>
              </a:xfrm>
              <a:prstGeom prst="line">
                <a:avLst/>
              </a:prstGeom>
              <a:ln w="38100">
                <a:solidFill>
                  <a:srgbClr val="0070C0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A3DA1869-B15A-BDEB-9D4A-761C1D7D78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35690" y="3322166"/>
                <a:ext cx="0" cy="2126134"/>
              </a:xfrm>
              <a:prstGeom prst="line">
                <a:avLst/>
              </a:prstGeom>
              <a:ln w="38100">
                <a:solidFill>
                  <a:srgbClr val="7030A0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B4CDD58B-0B17-C9A3-F64F-7B8D45470DC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35690" y="5248517"/>
                <a:ext cx="2660685" cy="0"/>
              </a:xfrm>
              <a:prstGeom prst="straightConnector1">
                <a:avLst/>
              </a:prstGeom>
              <a:ln w="76200">
                <a:solidFill>
                  <a:srgbClr val="7030A0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B31D899-2855-22CE-B603-241F28CD3522}"/>
                  </a:ext>
                </a:extLst>
              </p:cNvPr>
              <p:cNvSpPr txBox="1"/>
              <p:nvPr/>
            </p:nvSpPr>
            <p:spPr>
              <a:xfrm>
                <a:off x="6410323" y="5295247"/>
                <a:ext cx="2528708" cy="2696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altLang="ko-KR" sz="40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 % DSS exposure</a:t>
                </a:r>
                <a:endParaRPr lang="ko-KR" altLang="en-US" sz="40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FB2F9A4-A42F-B079-5FFD-6BFF958BF1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5026" b="89947" l="9927" r="97810">
                          <a14:foregroundMark x1="68903" y1="7387" x2="86277" y2="5026"/>
                          <a14:foregroundMark x1="86277" y1="5026" x2="97574" y2="9172"/>
                          <a14:foregroundMark x1="97226" y1="5026" x2="94891" y2="8201"/>
                          <a14:foregroundMark x1="81752" y1="16138" x2="78978" y2="14021"/>
                          <a14:backgroundMark x1="68613" y1="7143" x2="69051" y2="6878"/>
                          <a14:backgroundMark x1="98248" y1="9259" x2="97518" y2="8995"/>
                        </a14:backgroundRemoval>
                      </a14:imgEffect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67810" b="80342"/>
            <a:stretch/>
          </p:blipFill>
          <p:spPr>
            <a:xfrm>
              <a:off x="2698253" y="3622390"/>
              <a:ext cx="3125391" cy="1053231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5304782A-C93D-7E2D-3B72-861E020EFE3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5026" b="89947" l="9927" r="97810">
                          <a14:foregroundMark x1="68903" y1="7387" x2="86277" y2="5026"/>
                          <a14:foregroundMark x1="86277" y1="5026" x2="97574" y2="9172"/>
                          <a14:foregroundMark x1="97226" y1="5026" x2="94891" y2="8201"/>
                          <a14:foregroundMark x1="81752" y1="16138" x2="78978" y2="14021"/>
                          <a14:backgroundMark x1="68613" y1="7143" x2="69051" y2="6878"/>
                          <a14:backgroundMark x1="98248" y1="9259" x2="97518" y2="8995"/>
                        </a14:backgroundRemoval>
                      </a14:imgEffect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67810" b="80342"/>
            <a:stretch/>
          </p:blipFill>
          <p:spPr>
            <a:xfrm>
              <a:off x="3073303" y="5020179"/>
              <a:ext cx="3125391" cy="1053231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F9B9AF4-C8B6-37B0-9561-F29B4C567586}"/>
                </a:ext>
              </a:extLst>
            </p:cNvPr>
            <p:cNvSpPr txBox="1"/>
            <p:nvPr/>
          </p:nvSpPr>
          <p:spPr>
            <a:xfrm>
              <a:off x="15448482" y="14357994"/>
              <a:ext cx="5414606" cy="707886"/>
            </a:xfrm>
            <a:prstGeom prst="rect">
              <a:avLst/>
            </a:prstGeom>
            <a:solidFill>
              <a:schemeClr val="bg1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AU" altLang="ko-KR" sz="4000" b="1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 measurement</a:t>
              </a:r>
              <a:endParaRPr lang="ko-KR" altLang="en-US" sz="4000" b="1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524390C5-94FF-80B0-D3E7-94B9A0E785D6}"/>
                </a:ext>
              </a:extLst>
            </p:cNvPr>
            <p:cNvCxnSpPr>
              <a:cxnSpLocks/>
            </p:cNvCxnSpPr>
            <p:nvPr/>
          </p:nvCxnSpPr>
          <p:spPr>
            <a:xfrm>
              <a:off x="10149187" y="12951477"/>
              <a:ext cx="0" cy="48423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FBEE6D9-880A-E117-71A2-0E9477233126}"/>
                </a:ext>
              </a:extLst>
            </p:cNvPr>
            <p:cNvSpPr txBox="1"/>
            <p:nvPr/>
          </p:nvSpPr>
          <p:spPr>
            <a:xfrm>
              <a:off x="23313202" y="8059808"/>
              <a:ext cx="663785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altLang="ko-KR" sz="40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crifice</a:t>
              </a:r>
              <a:endParaRPr lang="ko-KR" altLang="en-US" sz="4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00E09FD-173E-EEBA-51EF-1BA04DB79154}"/>
                </a:ext>
              </a:extLst>
            </p:cNvPr>
            <p:cNvSpPr txBox="1"/>
            <p:nvPr/>
          </p:nvSpPr>
          <p:spPr>
            <a:xfrm>
              <a:off x="25652107" y="7413738"/>
              <a:ext cx="3125391" cy="7078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altLang="ko-KR" sz="4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ay 20</a:t>
              </a:r>
              <a:endParaRPr lang="ko-KR" altLang="en-US" sz="4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649FB4D2-3125-E55C-22BC-266E00E99430}"/>
                </a:ext>
              </a:extLst>
            </p:cNvPr>
            <p:cNvCxnSpPr>
              <a:cxnSpLocks/>
            </p:cNvCxnSpPr>
            <p:nvPr/>
          </p:nvCxnSpPr>
          <p:spPr>
            <a:xfrm>
              <a:off x="24801015" y="8025068"/>
              <a:ext cx="0" cy="5581102"/>
            </a:xfrm>
            <a:prstGeom prst="line">
              <a:avLst/>
            </a:prstGeom>
            <a:ln>
              <a:solidFill>
                <a:srgbClr val="FF0000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C8C00DEE-1644-1157-DA01-500E6314F733}"/>
                </a:ext>
              </a:extLst>
            </p:cNvPr>
            <p:cNvCxnSpPr>
              <a:cxnSpLocks/>
            </p:cNvCxnSpPr>
            <p:nvPr/>
          </p:nvCxnSpPr>
          <p:spPr>
            <a:xfrm>
              <a:off x="24807796" y="13682716"/>
              <a:ext cx="0" cy="48423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0CEE705-B4F4-C4FC-01D8-77B831CD94EC}"/>
                </a:ext>
              </a:extLst>
            </p:cNvPr>
            <p:cNvSpPr txBox="1"/>
            <p:nvPr/>
          </p:nvSpPr>
          <p:spPr>
            <a:xfrm>
              <a:off x="22439561" y="14241017"/>
              <a:ext cx="5414606" cy="707886"/>
            </a:xfrm>
            <a:prstGeom prst="rect">
              <a:avLst/>
            </a:prstGeom>
            <a:solidFill>
              <a:schemeClr val="bg1">
                <a:lumMod val="9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AU" altLang="ko-KR" sz="4000" b="1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 measurement</a:t>
              </a:r>
              <a:endParaRPr lang="ko-KR" altLang="en-US" sz="4000" b="1" dirty="0">
                <a:solidFill>
                  <a:schemeClr val="accent2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7C9339F-7D22-6EAD-D8A9-BDA5DEEBB789}"/>
              </a:ext>
            </a:extLst>
          </p:cNvPr>
          <p:cNvSpPr txBox="1"/>
          <p:nvPr/>
        </p:nvSpPr>
        <p:spPr>
          <a:xfrm>
            <a:off x="27214802" y="792533"/>
            <a:ext cx="79308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altLang="ko-KR" sz="3200" dirty="0"/>
              <a:t> Supplementary Figure 1</a:t>
            </a:r>
            <a:endParaRPr lang="ko-KR" altLang="en-US" sz="3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A890061-42D6-CD95-C3D2-D5963E896D75}"/>
              </a:ext>
            </a:extLst>
          </p:cNvPr>
          <p:cNvSpPr txBox="1"/>
          <p:nvPr/>
        </p:nvSpPr>
        <p:spPr>
          <a:xfrm>
            <a:off x="1822078" y="20643259"/>
            <a:ext cx="27252808" cy="17968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15000"/>
              </a:lnSpc>
              <a:spcAft>
                <a:spcPts val="1000"/>
              </a:spcAft>
              <a:buNone/>
            </a:pPr>
            <a:r>
              <a:rPr lang="en-AU" altLang="ko-KR" sz="36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1</a:t>
            </a:r>
            <a:endParaRPr lang="ko-KR" altLang="ko-KR" sz="2400" kern="1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1">
              <a:lnSpc>
                <a:spcPct val="200000"/>
              </a:lnSpc>
              <a:spcAft>
                <a:spcPts val="1000"/>
              </a:spcAft>
              <a:buNone/>
            </a:pPr>
            <a:r>
              <a:rPr lang="en-AU" altLang="ko-KR" sz="36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chematic diagrams of adult zebrafish experimental designs</a:t>
            </a:r>
            <a:endParaRPr lang="ko-KR" altLang="ko-KR" sz="2400" kern="1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4238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54A14AC-EF5F-95CE-A1F0-F984CCC50FE6}"/>
              </a:ext>
            </a:extLst>
          </p:cNvPr>
          <p:cNvSpPr txBox="1"/>
          <p:nvPr/>
        </p:nvSpPr>
        <p:spPr>
          <a:xfrm>
            <a:off x="27214802" y="792533"/>
            <a:ext cx="79308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altLang="ko-KR" sz="3200" dirty="0"/>
              <a:t> Supplementary Figure 2</a:t>
            </a:r>
            <a:endParaRPr lang="ko-KR" altLang="en-US" sz="3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6978994-0410-9413-2A68-4268EEF85412}"/>
              </a:ext>
            </a:extLst>
          </p:cNvPr>
          <p:cNvSpPr txBox="1"/>
          <p:nvPr/>
        </p:nvSpPr>
        <p:spPr>
          <a:xfrm>
            <a:off x="1828800" y="21733077"/>
            <a:ext cx="17576800" cy="144366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115000"/>
              </a:lnSpc>
              <a:spcAft>
                <a:spcPts val="1000"/>
              </a:spcAft>
              <a:buNone/>
              <a:defRPr sz="3600" b="1" kern="10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defRPr>
            </a:lvl1pPr>
          </a:lstStyle>
          <a:p>
            <a:r>
              <a:rPr lang="en-AU" altLang="ko-KR" dirty="0"/>
              <a:t>Supplementary Figure 2</a:t>
            </a:r>
            <a:endParaRPr lang="ko-KR" altLang="ko-KR" dirty="0"/>
          </a:p>
          <a:p>
            <a:r>
              <a:rPr lang="en-AU" altLang="ko-KR" b="0" dirty="0"/>
              <a:t>Growth of </a:t>
            </a:r>
            <a:r>
              <a:rPr lang="en-AU" altLang="ko-KR" b="0" i="1" dirty="0"/>
              <a:t>L. plantarum </a:t>
            </a:r>
            <a:r>
              <a:rPr lang="en-AU" altLang="ko-KR" b="0" dirty="0"/>
              <a:t>in </a:t>
            </a:r>
            <a:r>
              <a:rPr lang="en-AU" altLang="ko-KR" b="0" i="1" dirty="0"/>
              <a:t>S. horneri </a:t>
            </a:r>
            <a:r>
              <a:rPr lang="en-AU" altLang="ko-KR" b="0" dirty="0"/>
              <a:t>fucoidan-containing medium</a:t>
            </a:r>
            <a:endParaRPr lang="ko-KR" altLang="ko-KR" b="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ED97719-4827-91FD-81CB-EBA287665F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37242" y="9890760"/>
            <a:ext cx="11634216" cy="10584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7196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olorful squares with black text&#10;&#10;AI-generated content may be incorrect.">
            <a:extLst>
              <a:ext uri="{FF2B5EF4-FFF2-40B4-BE49-F238E27FC236}">
                <a16:creationId xmlns:a16="http://schemas.microsoft.com/office/drawing/2014/main" id="{BF680CEB-FCAF-2DBC-9117-0C0A4418C4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849"/>
          <a:stretch>
            <a:fillRect/>
          </a:stretch>
        </p:blipFill>
        <p:spPr>
          <a:xfrm>
            <a:off x="8923995" y="7605623"/>
            <a:ext cx="20138932" cy="11883412"/>
          </a:xfrm>
          <a:prstGeom prst="rect">
            <a:avLst/>
          </a:prstGeom>
        </p:spPr>
      </p:pic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8B99A1D-AC75-87AB-D9C1-8BD1FB7FF5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4087842"/>
              </p:ext>
            </p:extLst>
          </p:nvPr>
        </p:nvGraphicFramePr>
        <p:xfrm>
          <a:off x="7891617" y="19872492"/>
          <a:ext cx="14541908" cy="18445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49263">
                  <a:extLst>
                    <a:ext uri="{9D8B030D-6E8A-4147-A177-3AD203B41FA5}">
                      <a16:colId xmlns:a16="http://schemas.microsoft.com/office/drawing/2014/main" val="2276021311"/>
                    </a:ext>
                  </a:extLst>
                </a:gridCol>
                <a:gridCol w="1209921">
                  <a:extLst>
                    <a:ext uri="{9D8B030D-6E8A-4147-A177-3AD203B41FA5}">
                      <a16:colId xmlns:a16="http://schemas.microsoft.com/office/drawing/2014/main" val="1493739866"/>
                    </a:ext>
                  </a:extLst>
                </a:gridCol>
                <a:gridCol w="1669353">
                  <a:extLst>
                    <a:ext uri="{9D8B030D-6E8A-4147-A177-3AD203B41FA5}">
                      <a16:colId xmlns:a16="http://schemas.microsoft.com/office/drawing/2014/main" val="2643820415"/>
                    </a:ext>
                  </a:extLst>
                </a:gridCol>
                <a:gridCol w="1450423">
                  <a:extLst>
                    <a:ext uri="{9D8B030D-6E8A-4147-A177-3AD203B41FA5}">
                      <a16:colId xmlns:a16="http://schemas.microsoft.com/office/drawing/2014/main" val="1570701026"/>
                    </a:ext>
                  </a:extLst>
                </a:gridCol>
                <a:gridCol w="1450423">
                  <a:extLst>
                    <a:ext uri="{9D8B030D-6E8A-4147-A177-3AD203B41FA5}">
                      <a16:colId xmlns:a16="http://schemas.microsoft.com/office/drawing/2014/main" val="4157423785"/>
                    </a:ext>
                  </a:extLst>
                </a:gridCol>
                <a:gridCol w="1559886">
                  <a:extLst>
                    <a:ext uri="{9D8B030D-6E8A-4147-A177-3AD203B41FA5}">
                      <a16:colId xmlns:a16="http://schemas.microsoft.com/office/drawing/2014/main" val="2891450220"/>
                    </a:ext>
                  </a:extLst>
                </a:gridCol>
                <a:gridCol w="1450423">
                  <a:extLst>
                    <a:ext uri="{9D8B030D-6E8A-4147-A177-3AD203B41FA5}">
                      <a16:colId xmlns:a16="http://schemas.microsoft.com/office/drawing/2014/main" val="2600918710"/>
                    </a:ext>
                  </a:extLst>
                </a:gridCol>
                <a:gridCol w="1486449">
                  <a:extLst>
                    <a:ext uri="{9D8B030D-6E8A-4147-A177-3AD203B41FA5}">
                      <a16:colId xmlns:a16="http://schemas.microsoft.com/office/drawing/2014/main" val="62854931"/>
                    </a:ext>
                  </a:extLst>
                </a:gridCol>
                <a:gridCol w="1615767">
                  <a:extLst>
                    <a:ext uri="{9D8B030D-6E8A-4147-A177-3AD203B41FA5}">
                      <a16:colId xmlns:a16="http://schemas.microsoft.com/office/drawing/2014/main" val="2764591642"/>
                    </a:ext>
                  </a:extLst>
                </a:gridCol>
              </a:tblGrid>
              <a:tr h="636737"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F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 UPF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7765182"/>
                  </a:ext>
                </a:extLst>
              </a:tr>
              <a:tr h="628651"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 LP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4563131"/>
                  </a:ext>
                </a:extLst>
              </a:tr>
              <a:tr h="561056"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% DSS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AU" altLang="ko-KR" sz="3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ko-KR" altLang="en-US" sz="3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997643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A85F6B7-8C13-5F58-3EEE-38B853E59859}"/>
              </a:ext>
            </a:extLst>
          </p:cNvPr>
          <p:cNvSpPr txBox="1"/>
          <p:nvPr/>
        </p:nvSpPr>
        <p:spPr>
          <a:xfrm>
            <a:off x="27214802" y="792533"/>
            <a:ext cx="79308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altLang="ko-KR" sz="3200" dirty="0"/>
              <a:t> Supplementary Figure 3</a:t>
            </a:r>
            <a:endParaRPr lang="ko-KR" altLang="en-US" sz="3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A3C4495-E30D-53AE-A9B4-8A47F1B8E90F}"/>
              </a:ext>
            </a:extLst>
          </p:cNvPr>
          <p:cNvSpPr txBox="1"/>
          <p:nvPr/>
        </p:nvSpPr>
        <p:spPr>
          <a:xfrm>
            <a:off x="2638878" y="23798426"/>
            <a:ext cx="28679321" cy="208076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115000"/>
              </a:lnSpc>
              <a:spcAft>
                <a:spcPts val="1000"/>
              </a:spcAft>
              <a:buNone/>
              <a:defRPr sz="3600" b="1" kern="10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defRPr>
            </a:lvl1pPr>
          </a:lstStyle>
          <a:p>
            <a:r>
              <a:rPr lang="en-AU" altLang="ko-KR" dirty="0"/>
              <a:t>Supplementary Figure 3</a:t>
            </a:r>
            <a:endParaRPr lang="ko-KR" altLang="ko-KR" dirty="0"/>
          </a:p>
          <a:p>
            <a:r>
              <a:rPr lang="en-US" altLang="ko-KR" b="0" dirty="0"/>
              <a:t>The heatmap of relative abundances of core microbiota at the genus level in symbiotic diet-fed and </a:t>
            </a:r>
            <a:r>
              <a:rPr lang="en-AU" altLang="ko-KR" b="0" dirty="0"/>
              <a:t>0.5% DSS-induced zebrafish. </a:t>
            </a:r>
            <a:r>
              <a:rPr lang="en-US" altLang="ko-KR" b="0" dirty="0"/>
              <a:t>(SHF: </a:t>
            </a:r>
            <a:r>
              <a:rPr lang="en-US" altLang="ko-KR" b="0" i="1" dirty="0"/>
              <a:t>S. horneri </a:t>
            </a:r>
            <a:r>
              <a:rPr lang="en-US" altLang="ko-KR" b="0" dirty="0"/>
              <a:t>fucoidan, LP: </a:t>
            </a:r>
            <a:r>
              <a:rPr lang="en-US" altLang="ko-KR" b="0" i="1" dirty="0"/>
              <a:t>L. plantarum</a:t>
            </a:r>
            <a:r>
              <a:rPr lang="en-US" altLang="ko-KR" b="0" dirty="0"/>
              <a:t>, UPF</a:t>
            </a:r>
            <a:r>
              <a:rPr lang="en-US" altLang="ko-KR" b="0" i="1" dirty="0"/>
              <a:t>: U. pinnatifida </a:t>
            </a:r>
            <a:r>
              <a:rPr lang="en-US" altLang="ko-KR" b="0" dirty="0"/>
              <a:t>fucoidan)</a:t>
            </a:r>
            <a:endParaRPr lang="ko-KR" altLang="ko-KR" b="0" dirty="0"/>
          </a:p>
        </p:txBody>
      </p:sp>
    </p:spTree>
    <p:extLst>
      <p:ext uri="{BB962C8B-B14F-4D97-AF65-F5344CB8AC3E}">
        <p14:creationId xmlns:p14="http://schemas.microsoft.com/office/powerpoint/2010/main" val="3312016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8</TotalTime>
  <Words>144</Words>
  <Application>Microsoft Office PowerPoint</Application>
  <PresentationFormat>Custom</PresentationFormat>
  <Paragraphs>4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Manrope SemiBold</vt:lpstr>
      <vt:lpstr>맑은 고딕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du liyanage</dc:creator>
  <cp:lastModifiedBy>madu liyanage</cp:lastModifiedBy>
  <cp:revision>234</cp:revision>
  <dcterms:created xsi:type="dcterms:W3CDTF">2024-12-05T07:45:23Z</dcterms:created>
  <dcterms:modified xsi:type="dcterms:W3CDTF">2025-09-04T07:11:17Z</dcterms:modified>
</cp:coreProperties>
</file>